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1" d="100"/>
          <a:sy n="91" d="100"/>
        </p:scale>
        <p:origin x="-1507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4D8CB-A087-460F-A42B-A39BCB23ED1E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19FAA-470C-473C-858D-A4267F8D9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3604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4D8CB-A087-460F-A42B-A39BCB23ED1E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19FAA-470C-473C-858D-A4267F8D9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5731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4D8CB-A087-460F-A42B-A39BCB23ED1E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19FAA-470C-473C-858D-A4267F8D9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9858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4D8CB-A087-460F-A42B-A39BCB23ED1E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19FAA-470C-473C-858D-A4267F8D9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3907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4D8CB-A087-460F-A42B-A39BCB23ED1E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19FAA-470C-473C-858D-A4267F8D9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353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4D8CB-A087-460F-A42B-A39BCB23ED1E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19FAA-470C-473C-858D-A4267F8D9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1094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4D8CB-A087-460F-A42B-A39BCB23ED1E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19FAA-470C-473C-858D-A4267F8D9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7120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4D8CB-A087-460F-A42B-A39BCB23ED1E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19FAA-470C-473C-858D-A4267F8D9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4159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4D8CB-A087-460F-A42B-A39BCB23ED1E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19FAA-470C-473C-858D-A4267F8D9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56323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4D8CB-A087-460F-A42B-A39BCB23ED1E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19FAA-470C-473C-858D-A4267F8D9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7791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4D8CB-A087-460F-A42B-A39BCB23ED1E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19FAA-470C-473C-858D-A4267F8D9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2740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4D8CB-A087-460F-A42B-A39BCB23ED1E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219FAA-470C-473C-858D-A4267F8D9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6314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wmeng\Downloads\kneepainGWAS\Sup figure 2 GDF5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3608" y="364801"/>
            <a:ext cx="7213601" cy="4883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755576" y="5661248"/>
            <a:ext cx="81369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Supplementary </a:t>
            </a:r>
            <a:r>
              <a:rPr lang="en-US" smtClean="0"/>
              <a:t>figure</a:t>
            </a:r>
            <a:r>
              <a:rPr lang="en-US" smtClean="0"/>
              <a:t> </a:t>
            </a:r>
            <a:r>
              <a:rPr lang="en-US" dirty="0" smtClean="0"/>
              <a:t>2: the regional plot of the </a:t>
            </a:r>
            <a:r>
              <a:rPr lang="en-US" i="1" dirty="0" err="1" smtClean="0"/>
              <a:t>GDF5</a:t>
            </a:r>
            <a:r>
              <a:rPr lang="en-US" dirty="0" smtClean="0"/>
              <a:t> gene region based on </a:t>
            </a:r>
            <a:r>
              <a:rPr lang="en-US" dirty="0" err="1" smtClean="0"/>
              <a:t>GWAS</a:t>
            </a:r>
            <a:r>
              <a:rPr lang="en-US" dirty="0" smtClean="0"/>
              <a:t> on knee pain using the UK biobank cohort 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43995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2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onymous</dc:creator>
  <cp:lastModifiedBy>anonymous</cp:lastModifiedBy>
  <cp:revision>3</cp:revision>
  <dcterms:created xsi:type="dcterms:W3CDTF">2018-10-11T09:07:35Z</dcterms:created>
  <dcterms:modified xsi:type="dcterms:W3CDTF">2018-10-11T09:36:59Z</dcterms:modified>
</cp:coreProperties>
</file>